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1515DD-9D88-4235-A802-E1B04D639EB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FF4FA1-A9CB-4C97-8978-B5312805B2F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DA5064-BCA6-4197-AAE0-1EA7FEFA659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578199-C352-4DB8-A542-0AA6EC71FCB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13A0F5-6932-42A4-BA78-CCD7840C429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A7B4F5-EA0D-4364-B9B7-6193614A1C5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D0E9A8-D68A-4973-91F1-2E755ED3AE2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4C51A2-A3CC-4E98-B784-7600BACB447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B03760-3666-4C26-8F92-7CFF8969BE9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CC151D-FE36-40ED-9ED2-7B2C5EACCAA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C72840-F10C-4BA9-B3C4-19F834E7186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68E24F-F26B-46E8-B8CF-045459E7C17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DE4B7E8-E55D-4A02-8605-588AF33D2BF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217440" y="358920"/>
            <a:ext cx="6342120" cy="551952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463680" y="6103800"/>
            <a:ext cx="6087960" cy="11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)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Histogram of the 8-mer-association-with-RNAP between -1,000 bp and +500 bp for abundant 8-mers in the 13,861 common RNAP promoters.  8-mers that contain a CpG are noted in black. 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B-L)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Histogram of the 8-mer-association-with-RNAP in 200 bp increments from -1,200 bp to +1,000 bp.  8-mers that contain a CpG are noted in black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49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nci</cp:lastModifiedBy>
  <cp:lastPrinted>2007-10-01T20:46:28Z</cp:lastPrinted>
  <dcterms:modified xsi:type="dcterms:W3CDTF">2008-01-21T03:29:31Z</dcterms:modified>
  <cp:revision>390</cp:revision>
  <dc:subject/>
  <dc:title>PowerPoint Presentation</dc:title>
</cp:coreProperties>
</file>